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283"/>
    <p:restoredTop sz="94689"/>
  </p:normalViewPr>
  <p:slideViewPr>
    <p:cSldViewPr snapToGrid="0" snapToObjects="1">
      <p:cViewPr varScale="1">
        <p:scale>
          <a:sx n="55" d="100"/>
          <a:sy n="55" d="100"/>
        </p:scale>
        <p:origin x="192" y="1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57D04A-AA74-5E46-A528-B36B28E4C2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8BEE7E-5443-7544-BD4D-5A56B191D3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5A2040-D105-B24F-B497-7E73FBF42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E4CA83-8712-EC45-96B6-4D4C301B7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FD70DE-21B0-7C4B-84D7-F178AFB28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893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F6CF4F-99F1-194B-A9F3-848864D034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EF3681-3598-4F4E-93E7-59268462FC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E21F6E-77B0-6945-974C-0B96146E5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89C5B8-0896-1A48-A4A0-7E6207034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83B6F3-3350-2E42-8135-22759ED73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394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5CAC8B-2D5B-4048-AC06-7C2A843FCD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5C2935-3C95-274D-A82F-7C024E39D5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D3159F-B85E-6B4E-BF7D-387EC492F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16F24A-B148-444D-A8AA-414798FE6B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B9250D-C72D-B04D-8CF2-E7DC1F462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489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A1C36F-175E-6B48-8E2A-D46E4A37F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D33427-C66F-8040-8E15-F6C7864FCC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088E85-DD4D-B245-84E4-E6A708B3D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A9DB60-D38D-2240-886D-4A7BCCCF9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04752E-14AF-1E40-8598-6D4EDB3B5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485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F4134-E624-8D4E-970F-125A974FAE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E66686-5343-6E41-94F5-6A126B3496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10AB17-5F01-E941-8DA0-9D114308D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2ABB0B-2868-8441-8471-6D25A6F79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05E43-FB8D-8745-8727-69C685E53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591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54BB4-5DCB-DD45-988C-F7C41988A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4C89D2-EA31-D645-B2D6-AD4DFE8300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93D1C0-3291-A846-A058-363AB42B11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B6BCB8-7613-3C4C-B6EC-01764C26A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30CC5A-3CB7-ED46-ADE1-39E186172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69A302-58FA-D244-8FB0-C642C3C3D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790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993D3-D271-6F4C-B589-AF84C76827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432F44-9A76-1749-A1CD-312E5752B7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4AFE85-DA1E-A741-B0D8-02C945B480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6C2695-A2D8-1F40-BA9C-A9AD14CF47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5DF9F9-DD08-FE4D-B4DE-EA9288931B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019822-FBD7-2F40-9A6E-FC337A208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DC5947-29B4-5843-86B9-1573AAB6F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53E264B-D6B2-264F-BE06-C46341211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62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1A5E8F-4D59-1A4D-93C7-71B3A1F1AC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3482A8-9F57-3047-B2A8-0BEB7FC95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A40492-E99D-E64A-9971-3A470EB41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2AAB1B-06B2-BA46-8503-1C888A691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674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1707FD-D407-0A41-AB12-887354DBD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63FA4A2-F223-5E46-9953-AAD125788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44290B-5098-6A4A-8632-925CBE3D3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937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811F88-5CD9-C843-8490-40E6C635C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25E138-2E9B-104D-941B-54075582FE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C19D0E-B231-AD4C-A456-48B773C4C8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2B8AFB-C1B6-1F46-A2F7-53D232538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398E98-4463-C640-885C-645E55035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B69D83-569C-E94F-B907-AB5A87C40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421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C37C85-99FF-C245-8AB9-449A6913A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679373-AA34-324A-8BD5-01EC766805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31521E-74C5-9243-B6AE-A3136187B7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F60D2A-6762-9345-8215-6A43DF429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37680E-D14D-0241-AC33-B5D07C9F1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91C2B4-28D0-D54A-BD23-87F86FCBC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49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AD6C0DF-ED90-624E-9A90-757757A245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CE0BB5-98D5-254B-986B-E291B917B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0EA4D-5A3C-AF4C-AA72-F35310C2D1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C2A88C-BA57-A046-9AB4-8C80D13227A1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397257-3D3D-4147-9904-5340289AA5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821880-83C7-4747-AC24-7B1F06FECC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CCCD4C-073D-3247-ABBA-643A1B096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086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A3123-A9A6-054F-B99C-504258C8ED3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6FDA94-1F79-2348-9D69-49869724601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915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185D2C-4EE0-504E-B95A-375BE04F0D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e or </a:t>
            </a:r>
            <a:r>
              <a:rPr lang="en-US" dirty="0" err="1"/>
              <a:t>serium</a:t>
            </a:r>
            <a:r>
              <a:rPr lang="en-US" dirty="0"/>
              <a:t> </a:t>
            </a:r>
            <a:r>
              <a:rPr lang="en-US" dirty="0" err="1"/>
              <a:t>hCG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AD5B64-555B-4849-940C-DEB31DD214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Qualitative </a:t>
            </a:r>
            <a:r>
              <a:rPr lang="en-US" i="1" dirty="0" err="1"/>
              <a:t>hCG</a:t>
            </a:r>
            <a:r>
              <a:rPr lang="en-US" i="1" dirty="0"/>
              <a:t> Urine: 			</a:t>
            </a:r>
            <a:r>
              <a:rPr lang="en-US" dirty="0"/>
              <a:t>Positive</a:t>
            </a:r>
          </a:p>
          <a:p>
            <a:pPr marL="0" indent="0">
              <a:buNone/>
            </a:pPr>
            <a:r>
              <a:rPr lang="en-US" i="1" dirty="0"/>
              <a:t>Qualitative </a:t>
            </a:r>
            <a:r>
              <a:rPr lang="en-US" i="1" dirty="0" err="1"/>
              <a:t>hCG</a:t>
            </a:r>
            <a:r>
              <a:rPr lang="en-US" i="1" dirty="0"/>
              <a:t> Serum: 			</a:t>
            </a:r>
            <a:r>
              <a:rPr lang="en-US" dirty="0"/>
              <a:t>Positive (if used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0088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6B4D86-2BFA-554B-8AF4-3E13A07EEF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ectrocardiogra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ACD6A1-D197-EC4A-BD89-DE1CB95F6A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image9.jpg" descr="Timeline&#10;&#10;Description automatically generated with low confidence">
            <a:extLst>
              <a:ext uri="{FF2B5EF4-FFF2-40B4-BE49-F238E27FC236}">
                <a16:creationId xmlns:a16="http://schemas.microsoft.com/office/drawing/2014/main" id="{08831B6E-750F-7848-8B17-070192C3EB9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2464777" y="2046020"/>
            <a:ext cx="7262446" cy="3910548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36678279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E6CBC-9638-BB45-8AE6-FA0700EB5D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Right upper quadrant ultrasound from FAST exam ((Focused Assessment with Sonography for Trauma) with free fluid in Morrison’s pouch</a:t>
            </a:r>
            <a:r>
              <a:rPr lang="en-US" dirty="0">
                <a:effectLst/>
              </a:rPr>
              <a:t> )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E34B79-4F07-2A4E-B6DC-77E1CFF2D6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image6.png">
            <a:extLst>
              <a:ext uri="{FF2B5EF4-FFF2-40B4-BE49-F238E27FC236}">
                <a16:creationId xmlns:a16="http://schemas.microsoft.com/office/drawing/2014/main" id="{446E7162-936C-594B-AE04-A9EF2E044C0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2866293" y="2282508"/>
            <a:ext cx="5943600" cy="3894455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4264854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9</Words>
  <Application>Microsoft Macintosh PowerPoint</Application>
  <PresentationFormat>Widescreen</PresentationFormat>
  <Paragraphs>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timulus Inventory</vt:lpstr>
      <vt:lpstr>Urine or serium hCG</vt:lpstr>
      <vt:lpstr>Electrocardiogram</vt:lpstr>
      <vt:lpstr>Right upper quadrant ultrasound from FAST exam ((Focused Assessment with Sonography for Trauma) with free fluid in Morrison’s pouch 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Cheyenne Low</dc:creator>
  <cp:lastModifiedBy>Cheyenne Low</cp:lastModifiedBy>
  <cp:revision>5</cp:revision>
  <dcterms:created xsi:type="dcterms:W3CDTF">2022-01-20T10:06:16Z</dcterms:created>
  <dcterms:modified xsi:type="dcterms:W3CDTF">2022-01-20T10:08:46Z</dcterms:modified>
</cp:coreProperties>
</file>